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08661C-2B4F-4988-B10B-44FDCF82F9B6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0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9BE38F-5AB7-4CE6-A79F-1D3B77FFBD80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043FAF-2D37-44BE-990B-6240DC949E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E5D280-4460-4E5E-A25E-B26F3B5148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65F4BA-30BC-4DBA-A8F6-9BEE9B666CD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ED420C-2B0A-47FE-B414-EDC04E87936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AAE84E-DFE9-4127-BBA1-B338609334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75AE51-1361-4D82-81D0-7D2DBD9779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7D8B3C-56B3-44A2-9093-DC3CA1EFE8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B0E4B1-25C7-4310-981E-FC1108F7D8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AFBDF1-E24D-4645-9829-2E0574D551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67D642-FA0A-454A-BEA5-6A5B850A00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FF819-D83D-4055-90F6-43681BECA3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037B22-016D-4EA0-A72A-6CEC114ACE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1CE827-7B72-4D9F-8843-7B31A71563F5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hart 26" descr=""/>
          <p:cNvPicPr/>
          <p:nvPr/>
        </p:nvPicPr>
        <p:blipFill>
          <a:blip r:embed="rId1"/>
          <a:stretch/>
        </p:blipFill>
        <p:spPr>
          <a:xfrm>
            <a:off x="1752480" y="4786200"/>
            <a:ext cx="3062520" cy="1987560"/>
          </a:xfrm>
          <a:prstGeom prst="rect">
            <a:avLst/>
          </a:prstGeom>
          <a:ln w="0">
            <a:noFill/>
          </a:ln>
        </p:spPr>
      </p:pic>
      <p:sp>
        <p:nvSpPr>
          <p:cNvPr id="49" name="TextBox 17"/>
          <p:cNvSpPr/>
          <p:nvPr/>
        </p:nvSpPr>
        <p:spPr>
          <a:xfrm rot="16200000">
            <a:off x="995040" y="5385600"/>
            <a:ext cx="1230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elative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ell viability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CaixaDeTexto 22"/>
          <p:cNvSpPr/>
          <p:nvPr/>
        </p:nvSpPr>
        <p:spPr>
          <a:xfrm>
            <a:off x="2854440" y="6618240"/>
            <a:ext cx="141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Paclitaxel (n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2"/>
          <p:cNvSpPr/>
          <p:nvPr/>
        </p:nvSpPr>
        <p:spPr>
          <a:xfrm>
            <a:off x="2944440" y="502272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2"/>
          <p:cNvSpPr/>
          <p:nvPr/>
        </p:nvSpPr>
        <p:spPr>
          <a:xfrm>
            <a:off x="3254040" y="502452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2"/>
          <p:cNvSpPr/>
          <p:nvPr/>
        </p:nvSpPr>
        <p:spPr>
          <a:xfrm>
            <a:off x="3592080" y="502272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2"/>
          <p:cNvSpPr/>
          <p:nvPr/>
        </p:nvSpPr>
        <p:spPr>
          <a:xfrm>
            <a:off x="3880440" y="502272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2"/>
          <p:cNvSpPr/>
          <p:nvPr/>
        </p:nvSpPr>
        <p:spPr>
          <a:xfrm>
            <a:off x="4167720" y="502272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2"/>
          <p:cNvSpPr/>
          <p:nvPr/>
        </p:nvSpPr>
        <p:spPr>
          <a:xfrm>
            <a:off x="4478040" y="495144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ectangle 82"/>
          <p:cNvSpPr/>
          <p:nvPr/>
        </p:nvSpPr>
        <p:spPr>
          <a:xfrm>
            <a:off x="4924440" y="5460840"/>
            <a:ext cx="128520" cy="11124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83"/>
          <p:cNvSpPr/>
          <p:nvPr/>
        </p:nvSpPr>
        <p:spPr>
          <a:xfrm>
            <a:off x="4923000" y="5664240"/>
            <a:ext cx="144360" cy="14292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CaixaDeTexto 11"/>
          <p:cNvSpPr/>
          <p:nvPr/>
        </p:nvSpPr>
        <p:spPr>
          <a:xfrm>
            <a:off x="5070600" y="5380200"/>
            <a:ext cx="106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NSC si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CaixaDeTexto 11"/>
          <p:cNvSpPr/>
          <p:nvPr/>
        </p:nvSpPr>
        <p:spPr>
          <a:xfrm>
            <a:off x="5070600" y="5614920"/>
            <a:ext cx="136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FOXK2 si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23"/>
          <p:cNvSpPr/>
          <p:nvPr/>
        </p:nvSpPr>
        <p:spPr>
          <a:xfrm>
            <a:off x="4933440" y="8866080"/>
            <a:ext cx="191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" name="Chart 24" descr=""/>
          <p:cNvPicPr/>
          <p:nvPr/>
        </p:nvPicPr>
        <p:blipFill>
          <a:blip r:embed="rId2"/>
          <a:stretch/>
        </p:blipFill>
        <p:spPr>
          <a:xfrm>
            <a:off x="334800" y="4548240"/>
            <a:ext cx="3151440" cy="2968560"/>
          </a:xfrm>
          <a:prstGeom prst="rect">
            <a:avLst/>
          </a:prstGeom>
          <a:ln w="0">
            <a:noFill/>
          </a:ln>
        </p:spPr>
      </p:pic>
      <p:pic>
        <p:nvPicPr>
          <p:cNvPr id="63" name="Chart 25" descr=""/>
          <p:cNvPicPr/>
          <p:nvPr/>
        </p:nvPicPr>
        <p:blipFill>
          <a:blip r:embed="rId3"/>
          <a:stretch/>
        </p:blipFill>
        <p:spPr>
          <a:xfrm>
            <a:off x="3481560" y="4602240"/>
            <a:ext cx="3114360" cy="2809800"/>
          </a:xfrm>
          <a:prstGeom prst="rect">
            <a:avLst/>
          </a:prstGeom>
          <a:ln w="0">
            <a:noFill/>
          </a:ln>
        </p:spPr>
      </p:pic>
      <p:sp>
        <p:nvSpPr>
          <p:cNvPr id="64" name="Right Brace 26"/>
          <p:cNvSpPr/>
          <p:nvPr/>
        </p:nvSpPr>
        <p:spPr>
          <a:xfrm rot="5400000">
            <a:off x="4795920" y="5726880"/>
            <a:ext cx="84240" cy="1508040"/>
          </a:xfrm>
          <a:custGeom>
            <a:avLst/>
            <a:gdLst>
              <a:gd name="textAreaLeft" fmla="*/ 0 w 84240"/>
              <a:gd name="textAreaRight" fmla="*/ 30240 w 84240"/>
              <a:gd name="textAreaTop" fmla="*/ 2160 h 1508040"/>
              <a:gd name="textAreaBottom" fmla="*/ 1505880 h 1508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50"/>
                  <a:pt x="10800" y="100"/>
                </a:cubicBezTo>
                <a:lnTo>
                  <a:pt x="10800" y="10700"/>
                </a:lnTo>
                <a:cubicBezTo>
                  <a:pt x="10800" y="10750"/>
                  <a:pt x="16200" y="10800"/>
                  <a:pt x="21600" y="10800"/>
                </a:cubicBezTo>
                <a:cubicBezTo>
                  <a:pt x="16200" y="10800"/>
                  <a:pt x="10800" y="10850"/>
                  <a:pt x="10800" y="10900"/>
                </a:cubicBezTo>
                <a:lnTo>
                  <a:pt x="10800" y="21500"/>
                </a:lnTo>
                <a:cubicBezTo>
                  <a:pt x="10800" y="2155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1"/>
          <p:cNvSpPr/>
          <p:nvPr/>
        </p:nvSpPr>
        <p:spPr>
          <a:xfrm>
            <a:off x="4053960" y="6497640"/>
            <a:ext cx="194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 siFOXO3a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FOXK2 v pCM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Right Brace 28"/>
          <p:cNvSpPr/>
          <p:nvPr/>
        </p:nvSpPr>
        <p:spPr>
          <a:xfrm flipV="1" rot="16200000">
            <a:off x="4812120" y="4143960"/>
            <a:ext cx="85680" cy="1506600"/>
          </a:xfrm>
          <a:custGeom>
            <a:avLst/>
            <a:gdLst>
              <a:gd name="textAreaLeft" fmla="*/ 0 w 85680"/>
              <a:gd name="textAreaRight" fmla="*/ 30960 w 85680"/>
              <a:gd name="textAreaTop" fmla="*/ 2160 h 1506600"/>
              <a:gd name="textAreaBottom" fmla="*/ 1504440 h 1506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51"/>
                  <a:pt x="10800" y="102"/>
                </a:cubicBezTo>
                <a:lnTo>
                  <a:pt x="10800" y="10698"/>
                </a:lnTo>
                <a:cubicBezTo>
                  <a:pt x="10800" y="10749"/>
                  <a:pt x="16200" y="10800"/>
                  <a:pt x="21600" y="10800"/>
                </a:cubicBezTo>
                <a:cubicBezTo>
                  <a:pt x="16200" y="10800"/>
                  <a:pt x="10800" y="10851"/>
                  <a:pt x="10800" y="10902"/>
                </a:cubicBezTo>
                <a:lnTo>
                  <a:pt x="10800" y="21498"/>
                </a:lnTo>
                <a:cubicBezTo>
                  <a:pt x="10800" y="21549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"/>
          <p:cNvSpPr/>
          <p:nvPr/>
        </p:nvSpPr>
        <p:spPr>
          <a:xfrm>
            <a:off x="3961440" y="487980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57"/>
          <p:cNvSpPr/>
          <p:nvPr/>
        </p:nvSpPr>
        <p:spPr>
          <a:xfrm>
            <a:off x="4325760" y="487188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58"/>
          <p:cNvSpPr/>
          <p:nvPr/>
        </p:nvSpPr>
        <p:spPr>
          <a:xfrm>
            <a:off x="4690080" y="503244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59"/>
          <p:cNvSpPr/>
          <p:nvPr/>
        </p:nvSpPr>
        <p:spPr>
          <a:xfrm>
            <a:off x="5077800" y="519444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60"/>
          <p:cNvSpPr/>
          <p:nvPr/>
        </p:nvSpPr>
        <p:spPr>
          <a:xfrm>
            <a:off x="5417640" y="55069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"/>
          <p:cNvSpPr/>
          <p:nvPr/>
        </p:nvSpPr>
        <p:spPr>
          <a:xfrm>
            <a:off x="4022280" y="593100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62"/>
          <p:cNvSpPr/>
          <p:nvPr/>
        </p:nvSpPr>
        <p:spPr>
          <a:xfrm>
            <a:off x="4343760" y="592128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63"/>
          <p:cNvSpPr/>
          <p:nvPr/>
        </p:nvSpPr>
        <p:spPr>
          <a:xfrm>
            <a:off x="4708080" y="594684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64"/>
          <p:cNvSpPr/>
          <p:nvPr/>
        </p:nvSpPr>
        <p:spPr>
          <a:xfrm>
            <a:off x="5054760" y="603252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65"/>
          <p:cNvSpPr/>
          <p:nvPr/>
        </p:nvSpPr>
        <p:spPr>
          <a:xfrm>
            <a:off x="5401800" y="612468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66"/>
          <p:cNvSpPr/>
          <p:nvPr/>
        </p:nvSpPr>
        <p:spPr>
          <a:xfrm>
            <a:off x="4033440" y="4638600"/>
            <a:ext cx="1910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 siFOXO3a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FOXK2 v pCM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86"/>
          <p:cNvSpPr/>
          <p:nvPr/>
        </p:nvSpPr>
        <p:spPr>
          <a:xfrm>
            <a:off x="5774760" y="588816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87"/>
          <p:cNvSpPr/>
          <p:nvPr/>
        </p:nvSpPr>
        <p:spPr>
          <a:xfrm>
            <a:off x="6104880" y="595620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Right Brace 42"/>
          <p:cNvSpPr/>
          <p:nvPr/>
        </p:nvSpPr>
        <p:spPr>
          <a:xfrm rot="5400000">
            <a:off x="1379520" y="5894280"/>
            <a:ext cx="84240" cy="827280"/>
          </a:xfrm>
          <a:custGeom>
            <a:avLst/>
            <a:gdLst>
              <a:gd name="textAreaLeft" fmla="*/ 0 w 84240"/>
              <a:gd name="textAreaRight" fmla="*/ 30240 w 84240"/>
              <a:gd name="textAreaTop" fmla="*/ 2160 h 827280"/>
              <a:gd name="textAreaBottom" fmla="*/ 825120 h 827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2"/>
                  <a:pt x="10800" y="183"/>
                </a:cubicBezTo>
                <a:lnTo>
                  <a:pt x="10800" y="10617"/>
                </a:lnTo>
                <a:cubicBezTo>
                  <a:pt x="10800" y="10709"/>
                  <a:pt x="16200" y="10800"/>
                  <a:pt x="21600" y="10800"/>
                </a:cubicBezTo>
                <a:cubicBezTo>
                  <a:pt x="16200" y="10800"/>
                  <a:pt x="10800" y="10892"/>
                  <a:pt x="10800" y="10983"/>
                </a:cubicBezTo>
                <a:lnTo>
                  <a:pt x="10800" y="21417"/>
                </a:lnTo>
                <a:cubicBezTo>
                  <a:pt x="10800" y="21509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1"/>
          <p:cNvSpPr/>
          <p:nvPr/>
        </p:nvSpPr>
        <p:spPr>
          <a:xfrm>
            <a:off x="934560" y="6373800"/>
            <a:ext cx="14562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 siFOXO3a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FOXK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v pCM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Right Brace 44"/>
          <p:cNvSpPr/>
          <p:nvPr/>
        </p:nvSpPr>
        <p:spPr>
          <a:xfrm flipV="1" rot="16200000">
            <a:off x="1360800" y="4524840"/>
            <a:ext cx="85680" cy="792360"/>
          </a:xfrm>
          <a:custGeom>
            <a:avLst/>
            <a:gdLst>
              <a:gd name="textAreaLeft" fmla="*/ 0 w 85680"/>
              <a:gd name="textAreaRight" fmla="*/ 30960 w 85680"/>
              <a:gd name="textAreaTop" fmla="*/ 2160 h 792360"/>
              <a:gd name="textAreaBottom" fmla="*/ 790200 h 792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8"/>
                  <a:pt x="10800" y="195"/>
                </a:cubicBezTo>
                <a:lnTo>
                  <a:pt x="10800" y="10605"/>
                </a:lnTo>
                <a:cubicBezTo>
                  <a:pt x="10800" y="10703"/>
                  <a:pt x="16200" y="10800"/>
                  <a:pt x="21600" y="10800"/>
                </a:cubicBezTo>
                <a:cubicBezTo>
                  <a:pt x="16200" y="10800"/>
                  <a:pt x="10800" y="10898"/>
                  <a:pt x="10800" y="10995"/>
                </a:cubicBezTo>
                <a:lnTo>
                  <a:pt x="10800" y="21405"/>
                </a:lnTo>
                <a:cubicBezTo>
                  <a:pt x="10800" y="21503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2"/>
          <p:cNvSpPr/>
          <p:nvPr/>
        </p:nvSpPr>
        <p:spPr>
          <a:xfrm>
            <a:off x="948240" y="490392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57"/>
          <p:cNvSpPr/>
          <p:nvPr/>
        </p:nvSpPr>
        <p:spPr>
          <a:xfrm>
            <a:off x="1240200" y="492300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3"/>
          <p:cNvSpPr/>
          <p:nvPr/>
        </p:nvSpPr>
        <p:spPr>
          <a:xfrm>
            <a:off x="928080" y="583740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62"/>
          <p:cNvSpPr/>
          <p:nvPr/>
        </p:nvSpPr>
        <p:spPr>
          <a:xfrm>
            <a:off x="1249560" y="582768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63"/>
          <p:cNvSpPr/>
          <p:nvPr/>
        </p:nvSpPr>
        <p:spPr>
          <a:xfrm>
            <a:off x="1613880" y="600696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64"/>
          <p:cNvSpPr/>
          <p:nvPr/>
        </p:nvSpPr>
        <p:spPr>
          <a:xfrm>
            <a:off x="1960920" y="565776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65"/>
          <p:cNvSpPr/>
          <p:nvPr/>
        </p:nvSpPr>
        <p:spPr>
          <a:xfrm>
            <a:off x="2307600" y="599436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66"/>
          <p:cNvSpPr/>
          <p:nvPr/>
        </p:nvSpPr>
        <p:spPr>
          <a:xfrm>
            <a:off x="920520" y="4651200"/>
            <a:ext cx="1910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 siFOXO3a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FOXK2 v pCM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86"/>
          <p:cNvSpPr/>
          <p:nvPr/>
        </p:nvSpPr>
        <p:spPr>
          <a:xfrm>
            <a:off x="2661480" y="623880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87"/>
          <p:cNvSpPr/>
          <p:nvPr/>
        </p:nvSpPr>
        <p:spPr>
          <a:xfrm>
            <a:off x="2964960" y="622476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57"/>
          <p:cNvSpPr/>
          <p:nvPr/>
        </p:nvSpPr>
        <p:spPr>
          <a:xfrm>
            <a:off x="1647000" y="55483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56"/>
          <p:cNvSpPr/>
          <p:nvPr/>
        </p:nvSpPr>
        <p:spPr>
          <a:xfrm>
            <a:off x="4563360" y="4397400"/>
            <a:ext cx="109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CF-7 (48 h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57"/>
          <p:cNvSpPr/>
          <p:nvPr/>
        </p:nvSpPr>
        <p:spPr>
          <a:xfrm>
            <a:off x="1560600" y="4361040"/>
            <a:ext cx="109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CF-7 (72 h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6" name="Chart 50" descr=""/>
          <p:cNvPicPr/>
          <p:nvPr/>
        </p:nvPicPr>
        <p:blipFill>
          <a:blip r:embed="rId4"/>
          <a:stretch/>
        </p:blipFill>
        <p:spPr>
          <a:xfrm>
            <a:off x="1468440" y="1347840"/>
            <a:ext cx="5072040" cy="2644560"/>
          </a:xfrm>
          <a:prstGeom prst="rect">
            <a:avLst/>
          </a:prstGeom>
          <a:ln w="0">
            <a:noFill/>
          </a:ln>
        </p:spPr>
      </p:pic>
      <p:sp>
        <p:nvSpPr>
          <p:cNvPr id="97" name="Right Brace 51"/>
          <p:cNvSpPr/>
          <p:nvPr/>
        </p:nvSpPr>
        <p:spPr>
          <a:xfrm rot="5400000">
            <a:off x="3494520" y="2774160"/>
            <a:ext cx="83880" cy="1508040"/>
          </a:xfrm>
          <a:custGeom>
            <a:avLst/>
            <a:gdLst>
              <a:gd name="textAreaLeft" fmla="*/ 0 w 83880"/>
              <a:gd name="textAreaRight" fmla="*/ 30240 w 83880"/>
              <a:gd name="textAreaTop" fmla="*/ 2160 h 1508040"/>
              <a:gd name="textAreaBottom" fmla="*/ 1505880 h 1508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50"/>
                  <a:pt x="10800" y="100"/>
                </a:cubicBezTo>
                <a:lnTo>
                  <a:pt x="10800" y="10700"/>
                </a:lnTo>
                <a:cubicBezTo>
                  <a:pt x="10800" y="10750"/>
                  <a:pt x="16200" y="10800"/>
                  <a:pt x="21600" y="10800"/>
                </a:cubicBezTo>
                <a:cubicBezTo>
                  <a:pt x="16200" y="10800"/>
                  <a:pt x="10800" y="10850"/>
                  <a:pt x="10800" y="10900"/>
                </a:cubicBezTo>
                <a:lnTo>
                  <a:pt x="10800" y="21500"/>
                </a:lnTo>
                <a:cubicBezTo>
                  <a:pt x="10800" y="2155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1"/>
          <p:cNvSpPr/>
          <p:nvPr/>
        </p:nvSpPr>
        <p:spPr>
          <a:xfrm>
            <a:off x="2566440" y="3475080"/>
            <a:ext cx="194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 siFOXO3a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FOXK2 v pCM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Right Brace 53"/>
          <p:cNvSpPr/>
          <p:nvPr/>
        </p:nvSpPr>
        <p:spPr>
          <a:xfrm flipV="1" rot="16200000">
            <a:off x="3405600" y="983160"/>
            <a:ext cx="85680" cy="1506600"/>
          </a:xfrm>
          <a:custGeom>
            <a:avLst/>
            <a:gdLst>
              <a:gd name="textAreaLeft" fmla="*/ 0 w 85680"/>
              <a:gd name="textAreaRight" fmla="*/ 30960 w 85680"/>
              <a:gd name="textAreaTop" fmla="*/ 2160 h 1506600"/>
              <a:gd name="textAreaBottom" fmla="*/ 1504440 h 1506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51"/>
                  <a:pt x="10800" y="102"/>
                </a:cubicBezTo>
                <a:lnTo>
                  <a:pt x="10800" y="10698"/>
                </a:lnTo>
                <a:cubicBezTo>
                  <a:pt x="10800" y="10749"/>
                  <a:pt x="16200" y="10800"/>
                  <a:pt x="21600" y="10800"/>
                </a:cubicBezTo>
                <a:cubicBezTo>
                  <a:pt x="16200" y="10800"/>
                  <a:pt x="10800" y="10851"/>
                  <a:pt x="10800" y="10902"/>
                </a:cubicBezTo>
                <a:lnTo>
                  <a:pt x="10800" y="21498"/>
                </a:lnTo>
                <a:cubicBezTo>
                  <a:pt x="10800" y="21549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66"/>
          <p:cNvSpPr/>
          <p:nvPr/>
        </p:nvSpPr>
        <p:spPr>
          <a:xfrm>
            <a:off x="2626920" y="1477800"/>
            <a:ext cx="1910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 siFOXO3a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FOXK2 v pCM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57"/>
          <p:cNvSpPr/>
          <p:nvPr/>
        </p:nvSpPr>
        <p:spPr>
          <a:xfrm>
            <a:off x="3312720" y="234144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57"/>
          <p:cNvSpPr/>
          <p:nvPr/>
        </p:nvSpPr>
        <p:spPr>
          <a:xfrm>
            <a:off x="3846240" y="169704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57"/>
          <p:cNvSpPr/>
          <p:nvPr/>
        </p:nvSpPr>
        <p:spPr>
          <a:xfrm>
            <a:off x="2737800" y="284004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1"/>
          <p:cNvSpPr/>
          <p:nvPr/>
        </p:nvSpPr>
        <p:spPr>
          <a:xfrm rot="16200000">
            <a:off x="906480" y="2464560"/>
            <a:ext cx="113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% cell viabilit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9"/>
          <p:cNvSpPr/>
          <p:nvPr/>
        </p:nvSpPr>
        <p:spPr>
          <a:xfrm>
            <a:off x="205920" y="108252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9"/>
          <p:cNvSpPr/>
          <p:nvPr/>
        </p:nvSpPr>
        <p:spPr>
          <a:xfrm>
            <a:off x="154440" y="413388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57"/>
          <p:cNvSpPr/>
          <p:nvPr/>
        </p:nvSpPr>
        <p:spPr>
          <a:xfrm>
            <a:off x="2820600" y="1211400"/>
            <a:ext cx="64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12T14:16:50Z</dcterms:created>
  <dc:creator>gn912</dc:creator>
  <dc:description/>
  <dc:language>en-US</dc:language>
  <cp:lastModifiedBy>Eric Lam</cp:lastModifiedBy>
  <dcterms:modified xsi:type="dcterms:W3CDTF">2015-07-22T12:37:35Z</dcterms:modified>
  <cp:revision>205</cp:revision>
  <dc:subject/>
  <dc:title>PowerPoint Presentation</dc:title>
</cp:coreProperties>
</file>